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5400675" cy="47513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467"/>
    <p:restoredTop sz="94771"/>
  </p:normalViewPr>
  <p:slideViewPr>
    <p:cSldViewPr snapToGrid="0">
      <p:cViewPr varScale="1">
        <p:scale>
          <a:sx n="166" d="100"/>
          <a:sy n="166" d="100"/>
        </p:scale>
        <p:origin x="116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777600"/>
            <a:ext cx="4590574" cy="1654187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2495579"/>
            <a:ext cx="4050506" cy="1147152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766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732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252967"/>
            <a:ext cx="1164521" cy="402658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252967"/>
            <a:ext cx="3426053" cy="402658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628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791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184549"/>
            <a:ext cx="4658082" cy="1976445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3179692"/>
            <a:ext cx="4658082" cy="1039366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149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264837"/>
            <a:ext cx="2295287" cy="3014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264837"/>
            <a:ext cx="2295287" cy="3014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055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52968"/>
            <a:ext cx="4658082" cy="9183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164750"/>
            <a:ext cx="2284738" cy="570826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735576"/>
            <a:ext cx="2284738" cy="255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164750"/>
            <a:ext cx="2295990" cy="570826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735576"/>
            <a:ext cx="2295990" cy="255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00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685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63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16759"/>
            <a:ext cx="1741858" cy="1108657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684113"/>
            <a:ext cx="2734092" cy="3376565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425417"/>
            <a:ext cx="1741858" cy="2640760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76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16759"/>
            <a:ext cx="1741858" cy="1108657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684113"/>
            <a:ext cx="2734092" cy="3376565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425417"/>
            <a:ext cx="1741858" cy="2640760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893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252968"/>
            <a:ext cx="4658082" cy="9183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264837"/>
            <a:ext cx="4658082" cy="3014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4403834"/>
            <a:ext cx="1215152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4403834"/>
            <a:ext cx="1822728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4403834"/>
            <a:ext cx="1215152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49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kumimoji="1"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8EAF886-668D-808E-4AF3-3BE182BDB8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2682240" cy="150876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4A2BEF23-9A0E-2DAE-C113-1EA7D42FB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8436" y="0"/>
            <a:ext cx="2682240" cy="150876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FF4FEC1-EBA6-FADD-B219-915167F6B2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515432"/>
            <a:ext cx="2682240" cy="150876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7BF4A67B-5647-B6B1-42AA-09470256EE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8436" y="1515432"/>
            <a:ext cx="2682240" cy="150876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102FECE0-ED86-5AA7-477B-2C4EE5ADB2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" y="2982303"/>
            <a:ext cx="2682240" cy="150876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4E3135A-DFF0-A7D8-BEF8-7FA7791A94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18436" y="2982303"/>
            <a:ext cx="2682240" cy="150876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4F39916-E56A-C2EE-C4F4-2196EF8BF884}"/>
              </a:ext>
            </a:extLst>
          </p:cNvPr>
          <p:cNvSpPr txBox="1"/>
          <p:nvPr/>
        </p:nvSpPr>
        <p:spPr>
          <a:xfrm>
            <a:off x="227952" y="4309023"/>
            <a:ext cx="4980966" cy="4423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. Stratified analyses of OS according to PD-L1 tumor proportion score (&lt;1%, 1–49%, and ≥50%)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A) (B): PD-L1 &lt;1%, (C) (D): PD-L1 1-49%, (E) (F): PD-L1 50%≤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742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</TotalTime>
  <Words>51</Words>
  <Application>Microsoft Macintosh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saiki</dc:creator>
  <cp:lastModifiedBy>msaiki</cp:lastModifiedBy>
  <cp:revision>9</cp:revision>
  <dcterms:created xsi:type="dcterms:W3CDTF">2025-02-25T13:31:19Z</dcterms:created>
  <dcterms:modified xsi:type="dcterms:W3CDTF">2025-09-02T09:53:41Z</dcterms:modified>
</cp:coreProperties>
</file>